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77" r:id="rId2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49ED2"/>
    <a:srgbClr val="1A479E"/>
    <a:srgbClr val="FC8D59"/>
    <a:srgbClr val="91BFDB"/>
    <a:srgbClr val="F8766D"/>
    <a:srgbClr val="5ADDFE"/>
    <a:srgbClr val="56C5D4"/>
    <a:srgbClr val="EEEEE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E9639D4-E3E2-4D34-9284-5A2195B3D0D7}" styleName="Estilo clar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6711" autoAdjust="0"/>
  </p:normalViewPr>
  <p:slideViewPr>
    <p:cSldViewPr snapToGrid="0">
      <p:cViewPr>
        <p:scale>
          <a:sx n="238" d="100"/>
          <a:sy n="238" d="100"/>
        </p:scale>
        <p:origin x="-318" y="-45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DF1877C-87EF-46DC-99F9-8F6F7C731258}" type="datetimeFigureOut">
              <a:rPr lang="es-ES" smtClean="0"/>
              <a:t>17/02/2025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D210EEB-8E35-448A-970E-9E5DD1DA722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581120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AF583-4495-4468-A495-623E8A37E162}" type="datetimeFigureOut">
              <a:rPr lang="es-ES" smtClean="0"/>
              <a:t>17/02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794960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AF583-4495-4468-A495-623E8A37E162}" type="datetimeFigureOut">
              <a:rPr lang="es-ES" smtClean="0"/>
              <a:t>17/02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780661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AF583-4495-4468-A495-623E8A37E162}" type="datetimeFigureOut">
              <a:rPr lang="es-ES" smtClean="0"/>
              <a:t>17/02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077400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AF583-4495-4468-A495-623E8A37E162}" type="datetimeFigureOut">
              <a:rPr lang="es-ES" smtClean="0"/>
              <a:t>17/02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340415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AF583-4495-4468-A495-623E8A37E162}" type="datetimeFigureOut">
              <a:rPr lang="es-ES" smtClean="0"/>
              <a:t>17/02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103223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AF583-4495-4468-A495-623E8A37E162}" type="datetimeFigureOut">
              <a:rPr lang="es-ES" smtClean="0"/>
              <a:t>17/02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777464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AF583-4495-4468-A495-623E8A37E162}" type="datetimeFigureOut">
              <a:rPr lang="es-ES" smtClean="0"/>
              <a:t>17/02/2025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534548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AF583-4495-4468-A495-623E8A37E162}" type="datetimeFigureOut">
              <a:rPr lang="es-ES" smtClean="0"/>
              <a:t>17/02/2025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607525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AF583-4495-4468-A495-623E8A37E162}" type="datetimeFigureOut">
              <a:rPr lang="es-ES" smtClean="0"/>
              <a:t>17/02/2025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747202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AF583-4495-4468-A495-623E8A37E162}" type="datetimeFigureOut">
              <a:rPr lang="es-ES" smtClean="0"/>
              <a:t>17/02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635662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AF583-4495-4468-A495-623E8A37E162}" type="datetimeFigureOut">
              <a:rPr lang="es-ES" smtClean="0"/>
              <a:t>17/02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907965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CAF583-4495-4468-A495-623E8A37E162}" type="datetimeFigureOut">
              <a:rPr lang="es-ES" smtClean="0"/>
              <a:t>17/02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70C25-4999-4EBA-BB17-09200B1B6A8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11959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6DE0831-E557-BD9D-57E8-B320ED13ACD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2346D04B-0F05-8D4D-B0C4-4CA64AB11784}"/>
              </a:ext>
            </a:extLst>
          </p:cNvPr>
          <p:cNvSpPr txBox="1"/>
          <p:nvPr/>
        </p:nvSpPr>
        <p:spPr>
          <a:xfrm>
            <a:off x="3169456" y="100512"/>
            <a:ext cx="35511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5</a:t>
            </a:r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AFA358DE-FDE7-3C6C-7EB6-5E1E43BB02A0}"/>
              </a:ext>
            </a:extLst>
          </p:cNvPr>
          <p:cNvSpPr txBox="1"/>
          <p:nvPr/>
        </p:nvSpPr>
        <p:spPr>
          <a:xfrm>
            <a:off x="309990" y="3327840"/>
            <a:ext cx="616701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5 | Differentially methylated </a:t>
            </a:r>
            <a:r>
              <a:rPr lang="en-GB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CpGs</a:t>
            </a:r>
            <a:r>
              <a:rPr lang="en-GB" sz="700" b="1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Supervised 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clustered heatmap representation of differentially methylated </a:t>
            </a:r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CpGs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between supercentenarian (orange) and control population (blue).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Grupo 4">
            <a:extLst>
              <a:ext uri="{FF2B5EF4-FFF2-40B4-BE49-F238E27FC236}">
                <a16:creationId xmlns:a16="http://schemas.microsoft.com/office/drawing/2014/main" id="{E1336688-0D4A-22E2-C8DE-3E823F9F2BD8}"/>
              </a:ext>
            </a:extLst>
          </p:cNvPr>
          <p:cNvGrpSpPr/>
          <p:nvPr/>
        </p:nvGrpSpPr>
        <p:grpSpPr>
          <a:xfrm>
            <a:off x="3139093" y="918704"/>
            <a:ext cx="1360691" cy="747906"/>
            <a:chOff x="2676069" y="1215237"/>
            <a:chExt cx="1360691" cy="747906"/>
          </a:xfrm>
        </p:grpSpPr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id="{7A76CCB5-24BD-8EB8-4B98-7FA5C48E793C}"/>
                </a:ext>
              </a:extLst>
            </p:cNvPr>
            <p:cNvSpPr txBox="1"/>
            <p:nvPr/>
          </p:nvSpPr>
          <p:spPr>
            <a:xfrm>
              <a:off x="2676069" y="1574356"/>
              <a:ext cx="60382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Methylation</a:t>
              </a:r>
            </a:p>
          </p:txBody>
        </p:sp>
        <p:grpSp>
          <p:nvGrpSpPr>
            <p:cNvPr id="9" name="Grupo 8">
              <a:extLst>
                <a:ext uri="{FF2B5EF4-FFF2-40B4-BE49-F238E27FC236}">
                  <a16:creationId xmlns:a16="http://schemas.microsoft.com/office/drawing/2014/main" id="{2812A0D9-88B8-EC4C-102A-8A926D31A73A}"/>
                </a:ext>
              </a:extLst>
            </p:cNvPr>
            <p:cNvGrpSpPr/>
            <p:nvPr/>
          </p:nvGrpSpPr>
          <p:grpSpPr>
            <a:xfrm>
              <a:off x="2740491" y="1215237"/>
              <a:ext cx="1296269" cy="301925"/>
              <a:chOff x="971052" y="2275474"/>
              <a:chExt cx="1296269" cy="301925"/>
            </a:xfrm>
          </p:grpSpPr>
          <p:sp>
            <p:nvSpPr>
              <p:cNvPr id="16" name="CuadroTexto 15">
                <a:extLst>
                  <a:ext uri="{FF2B5EF4-FFF2-40B4-BE49-F238E27FC236}">
                    <a16:creationId xmlns:a16="http://schemas.microsoft.com/office/drawing/2014/main" id="{CCA8EFA9-45A7-85B8-4983-EA438D7CEECD}"/>
                  </a:ext>
                </a:extLst>
              </p:cNvPr>
              <p:cNvSpPr txBox="1"/>
              <p:nvPr/>
            </p:nvSpPr>
            <p:spPr>
              <a:xfrm>
                <a:off x="1030709" y="2275474"/>
                <a:ext cx="123661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M116</a:t>
                </a:r>
              </a:p>
            </p:txBody>
          </p:sp>
          <p:sp>
            <p:nvSpPr>
              <p:cNvPr id="17" name="CuadroTexto 16">
                <a:extLst>
                  <a:ext uri="{FF2B5EF4-FFF2-40B4-BE49-F238E27FC236}">
                    <a16:creationId xmlns:a16="http://schemas.microsoft.com/office/drawing/2014/main" id="{268A7279-D8DC-88A8-7D77-E83B64F78F06}"/>
                  </a:ext>
                </a:extLst>
              </p:cNvPr>
              <p:cNvSpPr txBox="1"/>
              <p:nvPr/>
            </p:nvSpPr>
            <p:spPr>
              <a:xfrm>
                <a:off x="1030709" y="2392733"/>
                <a:ext cx="102591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Ctrl population</a:t>
                </a:r>
              </a:p>
            </p:txBody>
          </p:sp>
          <p:pic>
            <p:nvPicPr>
              <p:cNvPr id="18" name="Imagen 17">
                <a:extLst>
                  <a:ext uri="{FF2B5EF4-FFF2-40B4-BE49-F238E27FC236}">
                    <a16:creationId xmlns:a16="http://schemas.microsoft.com/office/drawing/2014/main" id="{1162740F-4F42-AE72-E5D0-5BB6C912A85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rcRect l="87961" t="34748" r="9702" b="57874"/>
              <a:stretch/>
            </p:blipFill>
            <p:spPr>
              <a:xfrm rot="10800000">
                <a:off x="971052" y="2289210"/>
                <a:ext cx="133041" cy="280085"/>
              </a:xfrm>
              <a:prstGeom prst="rect">
                <a:avLst/>
              </a:prstGeom>
            </p:spPr>
          </p:pic>
        </p:grpSp>
        <p:grpSp>
          <p:nvGrpSpPr>
            <p:cNvPr id="12" name="Grupo 11">
              <a:extLst>
                <a:ext uri="{FF2B5EF4-FFF2-40B4-BE49-F238E27FC236}">
                  <a16:creationId xmlns:a16="http://schemas.microsoft.com/office/drawing/2014/main" id="{BCC6DCEA-0B19-BC4A-9E98-598087B893C4}"/>
                </a:ext>
              </a:extLst>
            </p:cNvPr>
            <p:cNvGrpSpPr/>
            <p:nvPr/>
          </p:nvGrpSpPr>
          <p:grpSpPr>
            <a:xfrm>
              <a:off x="2676069" y="1728329"/>
              <a:ext cx="644902" cy="234814"/>
              <a:chOff x="1867244" y="2253702"/>
              <a:chExt cx="644902" cy="234814"/>
            </a:xfrm>
          </p:grpSpPr>
          <p:pic>
            <p:nvPicPr>
              <p:cNvPr id="13" name="Imagen 12">
                <a:extLst>
                  <a:ext uri="{FF2B5EF4-FFF2-40B4-BE49-F238E27FC236}">
                    <a16:creationId xmlns:a16="http://schemas.microsoft.com/office/drawing/2014/main" id="{17E81517-25DF-C003-7696-46BFF185BFA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70991" t="47013" r="25266" b="31321"/>
              <a:stretch/>
            </p:blipFill>
            <p:spPr>
              <a:xfrm rot="5400000">
                <a:off x="2090583" y="2106967"/>
                <a:ext cx="102636" cy="396106"/>
              </a:xfrm>
              <a:prstGeom prst="rect">
                <a:avLst/>
              </a:prstGeom>
            </p:spPr>
          </p:pic>
          <p:sp>
            <p:nvSpPr>
              <p:cNvPr id="15" name="CuadroTexto 14">
                <a:extLst>
                  <a:ext uri="{FF2B5EF4-FFF2-40B4-BE49-F238E27FC236}">
                    <a16:creationId xmlns:a16="http://schemas.microsoft.com/office/drawing/2014/main" id="{7057F167-B380-F117-C677-880158E219B1}"/>
                  </a:ext>
                </a:extLst>
              </p:cNvPr>
              <p:cNvSpPr txBox="1"/>
              <p:nvPr/>
            </p:nvSpPr>
            <p:spPr>
              <a:xfrm>
                <a:off x="1867244" y="2303850"/>
                <a:ext cx="64490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0     0.5     1</a:t>
                </a:r>
              </a:p>
            </p:txBody>
          </p:sp>
        </p:grpSp>
      </p:grpSp>
      <p:pic>
        <p:nvPicPr>
          <p:cNvPr id="19" name="Imagen 18">
            <a:extLst>
              <a:ext uri="{FF2B5EF4-FFF2-40B4-BE49-F238E27FC236}">
                <a16:creationId xmlns:a16="http://schemas.microsoft.com/office/drawing/2014/main" id="{1B0DAF6B-4D6F-0B40-B0F9-1C7317F7F747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r="35210"/>
          <a:stretch/>
        </p:blipFill>
        <p:spPr>
          <a:xfrm>
            <a:off x="373510" y="545165"/>
            <a:ext cx="2750689" cy="26144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0251989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0545</TotalTime>
  <Words>39</Words>
  <Application>Microsoft Office PowerPoint</Application>
  <PresentationFormat>A4 (210 x 297 mm)</PresentationFormat>
  <Paragraphs>6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>HP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Eloy Santos</dc:creator>
  <cp:lastModifiedBy>Eloy Santos</cp:lastModifiedBy>
  <cp:revision>333</cp:revision>
  <cp:lastPrinted>2024-12-23T09:31:56Z</cp:lastPrinted>
  <dcterms:created xsi:type="dcterms:W3CDTF">2024-03-13T15:19:51Z</dcterms:created>
  <dcterms:modified xsi:type="dcterms:W3CDTF">2025-02-17T15:02:16Z</dcterms:modified>
</cp:coreProperties>
</file>